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827" autoAdjust="0"/>
    <p:restoredTop sz="94660"/>
  </p:normalViewPr>
  <p:slideViewPr>
    <p:cSldViewPr snapToGrid="0">
      <p:cViewPr>
        <p:scale>
          <a:sx n="100" d="100"/>
          <a:sy n="100" d="100"/>
        </p:scale>
        <p:origin x="1032" y="-5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7204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4325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4033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878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1674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2647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9173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977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020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2623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810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118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044" y="7223"/>
            <a:ext cx="21653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0" y="5649099"/>
            <a:ext cx="9144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tection of senescence-related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arker (p53, p16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INK4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p21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waf1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hTERT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expression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w proliferative DPSC sub-population,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2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2-10PDs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ur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xtended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ultur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ith or without exogenous H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50-20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.  β-actin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as used as the housekeeping gene.  Right-hand lanes represent separate total human RNA positive controls, water and RT negative controls.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= base pairs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 smtClean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FAFD5BF-8485-4C1C-8A47-C9062467CF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4570" y="638432"/>
            <a:ext cx="4329984" cy="338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4027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59</TotalTime>
  <Words>7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ardiff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Paper</dc:title>
  <dc:creator>insrv</dc:creator>
  <cp:lastModifiedBy>Ryan Moseley</cp:lastModifiedBy>
  <cp:revision>299</cp:revision>
  <cp:lastPrinted>2018-10-18T13:09:14Z</cp:lastPrinted>
  <dcterms:created xsi:type="dcterms:W3CDTF">2017-05-24T09:17:58Z</dcterms:created>
  <dcterms:modified xsi:type="dcterms:W3CDTF">2020-10-22T11:18:38Z</dcterms:modified>
</cp:coreProperties>
</file>